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3" r:id="rId7"/>
    <p:sldId id="264" r:id="rId8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117" d="100"/>
          <a:sy n="117" d="100"/>
        </p:scale>
        <p:origin x="80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25E6814-6C50-EA49-AE35-C373483120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53671C7-9671-BF7E-0B00-53B52595836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7D1528A-FAA1-90EE-930E-A76A67D80C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D593F-9114-6140-AE19-A032B26B2669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023A318-08CD-C33E-2B65-306A57D3DC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7451809-ADE2-36B9-2ACC-4B4A7993D6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8DA7-9748-414C-98C3-0D4601DC31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70330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383EF69-BDCE-48BB-F583-9F2D26B9DE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1EED4DF-F7C5-7E1C-BE04-4E08F7C9E2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FCDB4D7-855C-1BE7-EF02-91F936C8FA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D593F-9114-6140-AE19-A032B26B2669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746B8AA-0724-6DA2-57AC-B3F6FFCB4F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44AD0C0-90C5-0E28-2DD3-1FDB61E981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8DA7-9748-414C-98C3-0D4601DC31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9638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F3DD02A-2F10-01D4-593A-8C4A88532AF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3F94514-07A7-48C2-8023-E7F635FAA2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6F92604-85D5-8904-A508-4658BB84E7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D593F-9114-6140-AE19-A032B26B2669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847B8DC-AAF9-AF30-358B-383AEC9C69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C841554-1DE8-D7C6-0D4D-7F26404BC5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8DA7-9748-414C-98C3-0D4601DC31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75514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EBA0CB7-520F-5130-D917-6B2AD2AC87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265CDB4-BEAD-0D64-14F7-BAF93B2B0C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E087E0-F025-2D7B-B289-153376B49E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D593F-9114-6140-AE19-A032B26B2669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FEFD315-B91A-8B7C-8686-C2548E5F5B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48CCB0E-B16A-92C9-D2BC-CB3E87890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8DA7-9748-414C-98C3-0D4601DC31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25270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CFBA22E-EEF0-1A45-3D4E-C7EF136388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619A259-7113-5CCB-3FCF-5EFFECA338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C0DE4AB-7215-4006-6C7D-B3DDDA6E5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D593F-9114-6140-AE19-A032B26B2669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CA24CF9-8465-4B94-4BD3-A20608456A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89F8CC0-B69A-81C9-D582-89BF34D815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8DA7-9748-414C-98C3-0D4601DC31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532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5A6DE1F-AA87-6094-6BDB-09C4D8CD42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9ACC93F-3E20-6B16-45FE-264D0CC79E9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7EFBE99-3E9C-B3DB-3603-1E5845DA1A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69241A6-CE0C-1DDE-4702-CC3F5DEB41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D593F-9114-6140-AE19-A032B26B2669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402639D-0DCD-86C9-5244-D548F4C8BB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D33D27A-2D83-528E-1DAD-91E8F1F3C6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8DA7-9748-414C-98C3-0D4601DC31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7522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850417-E4E1-4B70-B200-FBB05650FE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E5627C5-4545-7221-B03F-0509B22A55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0636435-6C81-2A70-A6E6-8F00490A5B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81E0143F-5FF0-0EBD-E6AC-5C8258679BD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00FB579A-38D2-0F00-3E10-8757028D530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62B257E-95CF-4DBF-EE59-BE6E558836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D593F-9114-6140-AE19-A032B26B2669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81EC5F2-2D14-E971-68E0-7B919D9BEA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92A56C8-2B6E-1212-34C9-28086A4D6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8DA7-9748-414C-98C3-0D4601DC31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3977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CBCB52F-71B7-AEC7-DAC3-5826685559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5B1430D-25B6-0FCF-62D1-C923E5F5B7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D593F-9114-6140-AE19-A032B26B2669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98A0999-DFE0-15EA-376B-C46F760EA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1C15633-BBA2-A9DE-299D-AA91C9C7E8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8DA7-9748-414C-98C3-0D4601DC31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6107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A55A358-EF58-7112-B775-02D0D3440E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D593F-9114-6140-AE19-A032B26B2669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022D18A-3669-25FF-DD25-24F410C82F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6220F88-61EE-FA85-4DE4-708003BED3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8DA7-9748-414C-98C3-0D4601DC31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51286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66AA8C6-BF45-B3CA-E512-FC3F2ADC89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1EEC7A7-A866-E4D9-7559-CF2E71B30C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682E35A-DBAC-8817-797D-517614EE39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5ABE348-66E7-8FBE-61E8-553652790A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D593F-9114-6140-AE19-A032B26B2669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AADBAC0-50D2-4293-405F-6EE6E960A0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9A9D59C-09B1-6D0C-D45C-A5F2C5A3D4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8DA7-9748-414C-98C3-0D4601DC31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06639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B83035-7E39-1992-521A-210A39C3AD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177B807-182F-67D8-D997-D1821D96FF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DFD7620-1725-778D-67A0-67FE5B527A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8E21683-94E7-4CAA-D59F-91E1B659B3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D593F-9114-6140-AE19-A032B26B2669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E1BB149-3AFC-2C07-D5EA-0DE44B93B7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C764BFB-7B8D-14D7-5B01-F9CAC1E609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8DA7-9748-414C-98C3-0D4601DC31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48328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CDCBBC8-C884-D89A-3372-D553906916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52D79C9-9BF0-0A5F-47CD-3523F35361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AA41F4F-87D5-8A60-8FA4-2EDDB66341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4D593F-9114-6140-AE19-A032B26B2669}" type="datetimeFigureOut">
              <a:rPr kumimoji="1" lang="ja-JP" altLang="en-US" smtClean="0"/>
              <a:t>2023/4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91D9869-53A2-9C44-86D1-534D8ED04E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7D7299C-C279-58AD-4048-52320B971A2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DA8DA7-9748-414C-98C3-0D4601DC31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1976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D78067C3-C087-0055-5FFE-3287AFD298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43679" y="916066"/>
            <a:ext cx="5481864" cy="5025868"/>
          </a:xfrm>
          <a:prstGeom prst="rect">
            <a:avLst/>
          </a:prstGeom>
        </p:spPr>
      </p:pic>
      <p:cxnSp>
        <p:nvCxnSpPr>
          <p:cNvPr id="6" name="直線矢印コネクタ 5">
            <a:extLst>
              <a:ext uri="{FF2B5EF4-FFF2-40B4-BE49-F238E27FC236}">
                <a16:creationId xmlns:a16="http://schemas.microsoft.com/office/drawing/2014/main" id="{C8BA62CD-38C5-F3CF-8F71-E2E1FF99BE5C}"/>
              </a:ext>
            </a:extLst>
          </p:cNvPr>
          <p:cNvCxnSpPr/>
          <p:nvPr/>
        </p:nvCxnSpPr>
        <p:spPr>
          <a:xfrm flipH="1" flipV="1">
            <a:off x="6096000" y="3679371"/>
            <a:ext cx="979714" cy="402772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60CEBC8-D94E-A330-65DC-33E721EE67A7}"/>
              </a:ext>
            </a:extLst>
          </p:cNvPr>
          <p:cNvSpPr txBox="1"/>
          <p:nvPr/>
        </p:nvSpPr>
        <p:spPr>
          <a:xfrm>
            <a:off x="7223408" y="3970564"/>
            <a:ext cx="202491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800" dirty="0">
                <a:effectLst/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Marking  landmark</a:t>
            </a:r>
            <a:r>
              <a:rPr lang="ja-JP" altLang="ja-JP">
                <a:effectLst/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 </a:t>
            </a:r>
            <a:endParaRPr kumimoji="1" lang="ja-JP" altLang="en-US">
              <a:latin typeface="Times New Roman" panose="02020603050405020304" pitchFamily="18" charset="0"/>
              <a:ea typeface="Meiryo" panose="020B0604030504040204" pitchFamily="34" charset="-128"/>
              <a:cs typeface="Times New Roman" panose="02020603050405020304" pitchFamily="18" charset="0"/>
            </a:endParaRPr>
          </a:p>
        </p:txBody>
      </p: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A9D923A4-FE7F-0628-74FF-502D895FD107}"/>
              </a:ext>
            </a:extLst>
          </p:cNvPr>
          <p:cNvCxnSpPr>
            <a:cxnSpLocks/>
          </p:cNvCxnSpPr>
          <p:nvPr/>
        </p:nvCxnSpPr>
        <p:spPr>
          <a:xfrm flipV="1">
            <a:off x="4082143" y="3880757"/>
            <a:ext cx="936171" cy="201386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13AB02D-D38F-1720-2887-CBF65488670F}"/>
              </a:ext>
            </a:extLst>
          </p:cNvPr>
          <p:cNvSpPr txBox="1"/>
          <p:nvPr/>
        </p:nvSpPr>
        <p:spPr>
          <a:xfrm>
            <a:off x="2155372" y="3897477"/>
            <a:ext cx="185499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8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ouviére's</a:t>
            </a:r>
            <a:r>
              <a:rPr lang="en-US" altLang="ja-JP" sz="1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sulcus</a:t>
            </a:r>
            <a:r>
              <a:rPr lang="ja-JP" altLang="ja-JP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>
              <a:latin typeface="Times New Roman" panose="02020603050405020304" pitchFamily="18" charset="0"/>
              <a:ea typeface="Meiryo" panose="020B060403050404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E288095-022B-8152-332C-F4ACFADAC60D}"/>
              </a:ext>
            </a:extLst>
          </p:cNvPr>
          <p:cNvSpPr txBox="1"/>
          <p:nvPr/>
        </p:nvSpPr>
        <p:spPr>
          <a:xfrm>
            <a:off x="7652657" y="3185295"/>
            <a:ext cx="1545771" cy="3693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1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egment IV</a:t>
            </a:r>
            <a:r>
              <a:rPr lang="ja-JP" altLang="ja-JP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2E4D1E87-B045-93EB-71E1-9DAC6242D92E}"/>
              </a:ext>
            </a:extLst>
          </p:cNvPr>
          <p:cNvCxnSpPr>
            <a:cxnSpLocks/>
          </p:cNvCxnSpPr>
          <p:nvPr/>
        </p:nvCxnSpPr>
        <p:spPr>
          <a:xfrm flipH="1">
            <a:off x="6618684" y="3401343"/>
            <a:ext cx="936172" cy="153284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F9A922B-4D36-0113-AFEF-56CC65455890}"/>
              </a:ext>
            </a:extLst>
          </p:cNvPr>
          <p:cNvSpPr txBox="1"/>
          <p:nvPr/>
        </p:nvSpPr>
        <p:spPr>
          <a:xfrm>
            <a:off x="566057" y="457200"/>
            <a:ext cx="700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fig.1</a:t>
            </a:r>
            <a:r>
              <a:rPr lang="ja-JP" altLang="ja-JP">
                <a:effectLst/>
              </a:rPr>
              <a:t> 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61291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35EA9857-9ABB-A131-A7D2-F162AAA646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31776" y="779225"/>
            <a:ext cx="4053539" cy="462009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13D230F-6BC5-EEBB-2385-87E935D54109}"/>
              </a:ext>
            </a:extLst>
          </p:cNvPr>
          <p:cNvSpPr txBox="1"/>
          <p:nvPr/>
        </p:nvSpPr>
        <p:spPr>
          <a:xfrm>
            <a:off x="2477891" y="1458685"/>
            <a:ext cx="141919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gallbladder</a:t>
            </a:r>
            <a:endParaRPr kumimoji="1" lang="ja-JP" altLang="en-US">
              <a:latin typeface="Times New Roman" panose="02020603050405020304" pitchFamily="18" charset="0"/>
              <a:ea typeface="Meiryo" panose="020B0604030504040204" pitchFamily="34" charset="-128"/>
              <a:cs typeface="Times New Roman" panose="02020603050405020304" pitchFamily="18" charset="0"/>
            </a:endParaRPr>
          </a:p>
        </p:txBody>
      </p:sp>
      <p:cxnSp>
        <p:nvCxnSpPr>
          <p:cNvPr id="6" name="直線矢印コネクタ 5">
            <a:extLst>
              <a:ext uri="{FF2B5EF4-FFF2-40B4-BE49-F238E27FC236}">
                <a16:creationId xmlns:a16="http://schemas.microsoft.com/office/drawing/2014/main" id="{E112B727-00F1-3AE4-608E-226D088A361B}"/>
              </a:ext>
            </a:extLst>
          </p:cNvPr>
          <p:cNvCxnSpPr>
            <a:cxnSpLocks/>
          </p:cNvCxnSpPr>
          <p:nvPr/>
        </p:nvCxnSpPr>
        <p:spPr>
          <a:xfrm>
            <a:off x="3744686" y="1744044"/>
            <a:ext cx="555171" cy="367785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C934848-D933-B492-01E3-0A326524CC63}"/>
              </a:ext>
            </a:extLst>
          </p:cNvPr>
          <p:cNvSpPr txBox="1"/>
          <p:nvPr/>
        </p:nvSpPr>
        <p:spPr>
          <a:xfrm>
            <a:off x="6096000" y="3505200"/>
            <a:ext cx="145185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Segment  IV</a:t>
            </a:r>
            <a:endParaRPr kumimoji="1" lang="ja-JP" altLang="en-US">
              <a:latin typeface="Times New Roman" panose="02020603050405020304" pitchFamily="18" charset="0"/>
              <a:ea typeface="Meiryo" panose="020B060403050404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C286E9D-0732-836E-B2B4-4A8AEA2EC79D}"/>
              </a:ext>
            </a:extLst>
          </p:cNvPr>
          <p:cNvSpPr txBox="1"/>
          <p:nvPr/>
        </p:nvSpPr>
        <p:spPr>
          <a:xfrm>
            <a:off x="566057" y="457200"/>
            <a:ext cx="700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fig.2</a:t>
            </a:r>
            <a:r>
              <a:rPr lang="ja-JP" altLang="ja-JP">
                <a:effectLst/>
              </a:rPr>
              <a:t> </a:t>
            </a:r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02A026D-90C3-0D83-809E-F9E77CA1EE37}"/>
              </a:ext>
            </a:extLst>
          </p:cNvPr>
          <p:cNvSpPr txBox="1"/>
          <p:nvPr/>
        </p:nvSpPr>
        <p:spPr>
          <a:xfrm>
            <a:off x="721245" y="3643698"/>
            <a:ext cx="28452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ifficult to expose at the SS-inner layer</a:t>
            </a:r>
            <a:r>
              <a:rPr lang="ja-JP" altLang="ja-JP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88DC0743-83F4-BA5E-8FC0-E72F6A88C043}"/>
              </a:ext>
            </a:extLst>
          </p:cNvPr>
          <p:cNvCxnSpPr>
            <a:cxnSpLocks/>
          </p:cNvCxnSpPr>
          <p:nvPr/>
        </p:nvCxnSpPr>
        <p:spPr>
          <a:xfrm flipV="1">
            <a:off x="3585500" y="3759115"/>
            <a:ext cx="1328057" cy="230834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534085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D80BD27-6971-2D6A-7ECF-DAA799FBDD18}"/>
              </a:ext>
            </a:extLst>
          </p:cNvPr>
          <p:cNvSpPr txBox="1"/>
          <p:nvPr/>
        </p:nvSpPr>
        <p:spPr>
          <a:xfrm>
            <a:off x="566057" y="457200"/>
            <a:ext cx="700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fig.3</a:t>
            </a:r>
            <a:r>
              <a:rPr lang="ja-JP" altLang="ja-JP">
                <a:effectLst/>
              </a:rPr>
              <a:t> </a:t>
            </a:r>
            <a:endParaRPr kumimoji="1" lang="ja-JP" altLang="en-US"/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C8DD1407-C053-F5E3-2452-99F88403CC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27729" y="457200"/>
            <a:ext cx="6952037" cy="5889600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8CE12A9-1E66-AFFF-DA07-991D31E1AC21}"/>
              </a:ext>
            </a:extLst>
          </p:cNvPr>
          <p:cNvSpPr txBox="1"/>
          <p:nvPr/>
        </p:nvSpPr>
        <p:spPr>
          <a:xfrm>
            <a:off x="7946570" y="4768334"/>
            <a:ext cx="2037444" cy="3693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18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ventral side of GB </a:t>
            </a:r>
            <a:endParaRPr lang="ja-JP" altLang="en-US"/>
          </a:p>
        </p:txBody>
      </p: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CDD111D9-DD4F-385E-9118-546CF367D35E}"/>
              </a:ext>
            </a:extLst>
          </p:cNvPr>
          <p:cNvCxnSpPr>
            <a:cxnSpLocks/>
          </p:cNvCxnSpPr>
          <p:nvPr/>
        </p:nvCxnSpPr>
        <p:spPr>
          <a:xfrm flipH="1" flipV="1">
            <a:off x="7040465" y="4615738"/>
            <a:ext cx="696944" cy="305192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304AF4A5-3567-587E-1023-AD5874C74FEA}"/>
              </a:ext>
            </a:extLst>
          </p:cNvPr>
          <p:cNvCxnSpPr>
            <a:cxnSpLocks/>
          </p:cNvCxnSpPr>
          <p:nvPr/>
        </p:nvCxnSpPr>
        <p:spPr>
          <a:xfrm flipH="1">
            <a:off x="5969518" y="2460172"/>
            <a:ext cx="681654" cy="207024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ED1787C-DB1C-6B1C-71E7-7F158D9C55EF}"/>
              </a:ext>
            </a:extLst>
          </p:cNvPr>
          <p:cNvSpPr txBox="1"/>
          <p:nvPr/>
        </p:nvSpPr>
        <p:spPr>
          <a:xfrm>
            <a:off x="6791471" y="2242262"/>
            <a:ext cx="2679100" cy="3693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dirty="0">
                <a:latin typeface="游明朝" panose="02020400000000000000" pitchFamily="18" charset="-128"/>
                <a:cs typeface="Times New Roman" panose="02020603050405020304" pitchFamily="18" charset="0"/>
              </a:rPr>
              <a:t>Necrotic </a:t>
            </a:r>
            <a:r>
              <a:rPr lang="en-US" altLang="ja-JP" sz="18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GB  mucosa</a:t>
            </a:r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957736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D80BD27-6971-2D6A-7ECF-DAA799FBDD18}"/>
              </a:ext>
            </a:extLst>
          </p:cNvPr>
          <p:cNvSpPr txBox="1"/>
          <p:nvPr/>
        </p:nvSpPr>
        <p:spPr>
          <a:xfrm>
            <a:off x="566057" y="457200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Fig. 4</a:t>
            </a:r>
            <a:endParaRPr kumimoji="1" lang="ja-JP" altLang="en-US"/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70B0A648-F898-4A2E-DD06-BC1CA3D39D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4700" y="349250"/>
            <a:ext cx="7493000" cy="6159500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431942B-311D-D8C7-9F61-628EFB59C1D7}"/>
              </a:ext>
            </a:extLst>
          </p:cNvPr>
          <p:cNvSpPr txBox="1"/>
          <p:nvPr/>
        </p:nvSpPr>
        <p:spPr>
          <a:xfrm>
            <a:off x="6389911" y="4877191"/>
            <a:ext cx="2242459" cy="3693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dirty="0">
                <a:latin typeface="游明朝" panose="02020400000000000000" pitchFamily="18" charset="-128"/>
                <a:cs typeface="Times New Roman" panose="02020603050405020304" pitchFamily="18" charset="0"/>
              </a:rPr>
              <a:t>V</a:t>
            </a:r>
            <a:r>
              <a:rPr lang="en-US" altLang="ja-JP" sz="18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entral side of GB </a:t>
            </a:r>
            <a:endParaRPr lang="ja-JP" altLang="en-US"/>
          </a:p>
        </p:txBody>
      </p: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84B88F1F-0F30-3E4D-F31F-14F810DBBAC5}"/>
              </a:ext>
            </a:extLst>
          </p:cNvPr>
          <p:cNvCxnSpPr>
            <a:cxnSpLocks/>
          </p:cNvCxnSpPr>
          <p:nvPr/>
        </p:nvCxnSpPr>
        <p:spPr>
          <a:xfrm flipH="1" flipV="1">
            <a:off x="5451150" y="4452453"/>
            <a:ext cx="696944" cy="305192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881F7C62-7FA5-6DF2-0947-1058A8F43162}"/>
              </a:ext>
            </a:extLst>
          </p:cNvPr>
          <p:cNvCxnSpPr>
            <a:cxnSpLocks/>
          </p:cNvCxnSpPr>
          <p:nvPr/>
        </p:nvCxnSpPr>
        <p:spPr>
          <a:xfrm flipH="1">
            <a:off x="5170714" y="619508"/>
            <a:ext cx="642258" cy="577921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6285193-5CF3-AE7D-4F60-59E9D96647D0}"/>
              </a:ext>
            </a:extLst>
          </p:cNvPr>
          <p:cNvSpPr txBox="1"/>
          <p:nvPr/>
        </p:nvSpPr>
        <p:spPr>
          <a:xfrm>
            <a:off x="5953271" y="401598"/>
            <a:ext cx="2679100" cy="3693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dirty="0">
                <a:latin typeface="游明朝" panose="02020400000000000000" pitchFamily="18" charset="-128"/>
                <a:cs typeface="Times New Roman" panose="02020603050405020304" pitchFamily="18" charset="0"/>
              </a:rPr>
              <a:t>Necrotic </a:t>
            </a:r>
            <a:r>
              <a:rPr lang="en-US" altLang="ja-JP" sz="18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GB  mucosa</a:t>
            </a:r>
            <a:endParaRPr lang="ja-JP" altLang="en-US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0E9D579-A956-D5C5-19DD-1CD7EA090A03}"/>
              </a:ext>
            </a:extLst>
          </p:cNvPr>
          <p:cNvSpPr txBox="1"/>
          <p:nvPr/>
        </p:nvSpPr>
        <p:spPr>
          <a:xfrm>
            <a:off x="2028672" y="619508"/>
            <a:ext cx="23147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Liver bed side of GB</a:t>
            </a:r>
            <a:r>
              <a:rPr lang="ja-JP" altLang="ja-JP">
                <a:effectLst/>
              </a:rPr>
              <a:t> </a:t>
            </a:r>
            <a:endParaRPr lang="ja-JP" altLang="en-US"/>
          </a:p>
        </p:txBody>
      </p:sp>
      <p:cxnSp>
        <p:nvCxnSpPr>
          <p:cNvPr id="16" name="直線矢印コネクタ 15">
            <a:extLst>
              <a:ext uri="{FF2B5EF4-FFF2-40B4-BE49-F238E27FC236}">
                <a16:creationId xmlns:a16="http://schemas.microsoft.com/office/drawing/2014/main" id="{A4FE299C-DFA6-D438-6EB7-DEF9DBDFBAAB}"/>
              </a:ext>
            </a:extLst>
          </p:cNvPr>
          <p:cNvCxnSpPr>
            <a:cxnSpLocks/>
          </p:cNvCxnSpPr>
          <p:nvPr/>
        </p:nvCxnSpPr>
        <p:spPr>
          <a:xfrm>
            <a:off x="3560902" y="1074483"/>
            <a:ext cx="554506" cy="245891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195376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D80BD27-6971-2D6A-7ECF-DAA799FBDD18}"/>
              </a:ext>
            </a:extLst>
          </p:cNvPr>
          <p:cNvSpPr txBox="1"/>
          <p:nvPr/>
        </p:nvSpPr>
        <p:spPr>
          <a:xfrm>
            <a:off x="566057" y="457200"/>
            <a:ext cx="760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dirty="0">
                <a:effectLst/>
                <a:latin typeface="游明朝" panose="02020400000000000000" pitchFamily="18" charset="-128"/>
                <a:cs typeface="Times New Roman" panose="02020603050405020304" pitchFamily="18" charset="0"/>
              </a:rPr>
              <a:t>fig. 5</a:t>
            </a:r>
            <a:r>
              <a:rPr lang="ja-JP" altLang="ja-JP">
                <a:effectLst/>
              </a:rPr>
              <a:t> </a:t>
            </a:r>
            <a:endParaRPr kumimoji="1" lang="ja-JP" altLang="en-US"/>
          </a:p>
        </p:txBody>
      </p: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49050686-A71B-1690-C0D8-F3D9555F85A1}"/>
              </a:ext>
            </a:extLst>
          </p:cNvPr>
          <p:cNvGrpSpPr/>
          <p:nvPr/>
        </p:nvGrpSpPr>
        <p:grpSpPr>
          <a:xfrm>
            <a:off x="2011462" y="88597"/>
            <a:ext cx="4740173" cy="3194779"/>
            <a:chOff x="2279650" y="367071"/>
            <a:chExt cx="10409227" cy="6008400"/>
          </a:xfrm>
        </p:grpSpPr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BF428516-0B2E-08D5-BA84-AB5878F3EE8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83640" y="367071"/>
              <a:ext cx="7481919" cy="6008400"/>
            </a:xfrm>
            <a:prstGeom prst="rect">
              <a:avLst/>
            </a:prstGeom>
          </p:spPr>
        </p:pic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A43FBA70-FC6A-CE2F-DEBB-A65E90E7965A}"/>
                </a:ext>
              </a:extLst>
            </p:cNvPr>
            <p:cNvSpPr txBox="1"/>
            <p:nvPr/>
          </p:nvSpPr>
          <p:spPr>
            <a:xfrm>
              <a:off x="8675816" y="4380967"/>
              <a:ext cx="4013061" cy="65337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-US" altLang="ja-JP" sz="18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Remnant of GB</a:t>
              </a:r>
              <a:r>
                <a:rPr lang="ja-JP" altLang="ja-JP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" name="直線矢印コネクタ 5">
              <a:extLst>
                <a:ext uri="{FF2B5EF4-FFF2-40B4-BE49-F238E27FC236}">
                  <a16:creationId xmlns:a16="http://schemas.microsoft.com/office/drawing/2014/main" id="{22D9D98C-94C3-BB88-5333-922EF3F4A05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829064" y="4661943"/>
              <a:ext cx="846752" cy="282832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0787944E-F13B-1E72-778D-B8B5896C2806}"/>
                </a:ext>
              </a:extLst>
            </p:cNvPr>
            <p:cNvSpPr txBox="1"/>
            <p:nvPr/>
          </p:nvSpPr>
          <p:spPr>
            <a:xfrm>
              <a:off x="2279650" y="3659948"/>
              <a:ext cx="2912974" cy="11434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ja-JP" sz="18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nfirming of bile juice</a:t>
              </a:r>
              <a:r>
                <a:rPr lang="ja-JP" altLang="ja-JP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" name="直線矢印コネクタ 8">
              <a:extLst>
                <a:ext uri="{FF2B5EF4-FFF2-40B4-BE49-F238E27FC236}">
                  <a16:creationId xmlns:a16="http://schemas.microsoft.com/office/drawing/2014/main" id="{B5CE1E5A-1533-373B-54A9-AC01C188E08D}"/>
                </a:ext>
              </a:extLst>
            </p:cNvPr>
            <p:cNvCxnSpPr>
              <a:cxnSpLocks/>
            </p:cNvCxnSpPr>
            <p:nvPr/>
          </p:nvCxnSpPr>
          <p:spPr>
            <a:xfrm>
              <a:off x="5371899" y="4232770"/>
              <a:ext cx="952701" cy="241748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4B601BAE-BA6E-15F4-C3ED-AFA4535F8036}"/>
              </a:ext>
            </a:extLst>
          </p:cNvPr>
          <p:cNvGrpSpPr/>
          <p:nvPr/>
        </p:nvGrpSpPr>
        <p:grpSpPr>
          <a:xfrm>
            <a:off x="637411" y="2698357"/>
            <a:ext cx="5473164" cy="3764363"/>
            <a:chOff x="81103" y="1613777"/>
            <a:chExt cx="7448175" cy="4533341"/>
          </a:xfrm>
        </p:grpSpPr>
        <p:pic>
          <p:nvPicPr>
            <p:cNvPr id="14" name="図 13">
              <a:extLst>
                <a:ext uri="{FF2B5EF4-FFF2-40B4-BE49-F238E27FC236}">
                  <a16:creationId xmlns:a16="http://schemas.microsoft.com/office/drawing/2014/main" id="{741DB78B-91D9-D276-B7BB-759C631FE4F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55620" y="2934925"/>
              <a:ext cx="4316162" cy="3212193"/>
            </a:xfrm>
            <a:prstGeom prst="rect">
              <a:avLst/>
            </a:prstGeom>
          </p:spPr>
        </p:pic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85514213-8047-2E74-B220-9F10269918EF}"/>
                </a:ext>
              </a:extLst>
            </p:cNvPr>
            <p:cNvSpPr txBox="1"/>
            <p:nvPr/>
          </p:nvSpPr>
          <p:spPr>
            <a:xfrm>
              <a:off x="81103" y="1613777"/>
              <a:ext cx="2872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08B121E7-F9EC-0A29-AC25-149DC768ECF3}"/>
                </a:ext>
              </a:extLst>
            </p:cNvPr>
            <p:cNvSpPr txBox="1"/>
            <p:nvPr/>
          </p:nvSpPr>
          <p:spPr>
            <a:xfrm>
              <a:off x="5214285" y="4508266"/>
              <a:ext cx="2314993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ja-JP" sz="1800" dirty="0" err="1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apraTy</a:t>
              </a:r>
              <a:r>
                <a:rPr lang="en-US" altLang="ja-JP" sz="18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® suture clips </a:t>
              </a:r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9" name="直線矢印コネクタ 18">
              <a:extLst>
                <a:ext uri="{FF2B5EF4-FFF2-40B4-BE49-F238E27FC236}">
                  <a16:creationId xmlns:a16="http://schemas.microsoft.com/office/drawing/2014/main" id="{FA290E3F-7DED-DDC7-D297-30A76DF3A16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790909" y="4400655"/>
              <a:ext cx="423376" cy="215222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6" name="図 15">
            <a:extLst>
              <a:ext uri="{FF2B5EF4-FFF2-40B4-BE49-F238E27FC236}">
                <a16:creationId xmlns:a16="http://schemas.microsoft.com/office/drawing/2014/main" id="{F0D4E470-668A-7ED4-1BC9-EF4FC1A55AE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09408" y="3323006"/>
            <a:ext cx="2919958" cy="2693103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7E46DF3-9233-97F1-D7CF-688AAF2EFE71}"/>
              </a:ext>
            </a:extLst>
          </p:cNvPr>
          <p:cNvSpPr txBox="1"/>
          <p:nvPr/>
        </p:nvSpPr>
        <p:spPr>
          <a:xfrm>
            <a:off x="1167666" y="2698357"/>
            <a:ext cx="229981" cy="3071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1230FCF-C6F5-0ADE-5B90-D6BCB75AD0CE}"/>
              </a:ext>
            </a:extLst>
          </p:cNvPr>
          <p:cNvSpPr txBox="1"/>
          <p:nvPr/>
        </p:nvSpPr>
        <p:spPr>
          <a:xfrm>
            <a:off x="7814514" y="5817935"/>
            <a:ext cx="1774195" cy="30713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8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apraTy</a:t>
            </a:r>
            <a:r>
              <a:rPr lang="en-US" altLang="ja-JP" sz="1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® suture clips 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0D6D6E43-81FA-008F-F687-F638291A509D}"/>
              </a:ext>
            </a:extLst>
          </p:cNvPr>
          <p:cNvCxnSpPr>
            <a:cxnSpLocks/>
          </p:cNvCxnSpPr>
          <p:nvPr/>
        </p:nvCxnSpPr>
        <p:spPr>
          <a:xfrm flipV="1">
            <a:off x="8982498" y="5178307"/>
            <a:ext cx="431013" cy="619884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FE69AABE-C782-F113-019F-6FD6D2FD9701}"/>
              </a:ext>
            </a:extLst>
          </p:cNvPr>
          <p:cNvGrpSpPr/>
          <p:nvPr/>
        </p:nvGrpSpPr>
        <p:grpSpPr>
          <a:xfrm>
            <a:off x="7188229" y="298450"/>
            <a:ext cx="4775170" cy="3130550"/>
            <a:chOff x="2228850" y="298450"/>
            <a:chExt cx="9650563" cy="6261100"/>
          </a:xfrm>
        </p:grpSpPr>
        <p:pic>
          <p:nvPicPr>
            <p:cNvPr id="25" name="図 24">
              <a:extLst>
                <a:ext uri="{FF2B5EF4-FFF2-40B4-BE49-F238E27FC236}">
                  <a16:creationId xmlns:a16="http://schemas.microsoft.com/office/drawing/2014/main" id="{7806B208-632F-612D-C5D0-529A91A60E1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228850" y="298450"/>
              <a:ext cx="7734300" cy="6261100"/>
            </a:xfrm>
            <a:prstGeom prst="rect">
              <a:avLst/>
            </a:prstGeom>
          </p:spPr>
        </p:pic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58901D9B-D05A-0196-8763-38C0F9A189E3}"/>
                </a:ext>
              </a:extLst>
            </p:cNvPr>
            <p:cNvSpPr txBox="1"/>
            <p:nvPr/>
          </p:nvSpPr>
          <p:spPr>
            <a:xfrm>
              <a:off x="8403671" y="3244334"/>
              <a:ext cx="3475742" cy="73866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-US" altLang="ja-JP" sz="18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Remnant of GB</a:t>
              </a:r>
              <a:r>
                <a:rPr lang="ja-JP" altLang="ja-JP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7" name="直線矢印コネクタ 26">
              <a:extLst>
                <a:ext uri="{FF2B5EF4-FFF2-40B4-BE49-F238E27FC236}">
                  <a16:creationId xmlns:a16="http://schemas.microsoft.com/office/drawing/2014/main" id="{C5D9F9DD-890A-7059-C4C2-9E044F402E1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543800" y="3493630"/>
              <a:ext cx="846751" cy="282832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E5DE9DC9-C29F-6FCF-710C-FF392B201C04}"/>
              </a:ext>
            </a:extLst>
          </p:cNvPr>
          <p:cNvCxnSpPr/>
          <p:nvPr/>
        </p:nvCxnSpPr>
        <p:spPr>
          <a:xfrm>
            <a:off x="1023257" y="2698357"/>
            <a:ext cx="0" cy="88428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6FF75D23-C4B6-D35E-A549-874E7ADC2920}"/>
              </a:ext>
            </a:extLst>
          </p:cNvPr>
          <p:cNvCxnSpPr>
            <a:cxnSpLocks/>
          </p:cNvCxnSpPr>
          <p:nvPr/>
        </p:nvCxnSpPr>
        <p:spPr>
          <a:xfrm flipH="1">
            <a:off x="566057" y="3109089"/>
            <a:ext cx="914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36EBC596-3F4A-3C69-7BF6-4A784C36A2A6}"/>
              </a:ext>
            </a:extLst>
          </p:cNvPr>
          <p:cNvSpPr txBox="1"/>
          <p:nvPr/>
        </p:nvSpPr>
        <p:spPr>
          <a:xfrm>
            <a:off x="648868" y="3212689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E1432CC5-97F6-868A-0E3C-D82CA10BA45E}"/>
              </a:ext>
            </a:extLst>
          </p:cNvPr>
          <p:cNvSpPr txBox="1"/>
          <p:nvPr/>
        </p:nvSpPr>
        <p:spPr>
          <a:xfrm>
            <a:off x="1136453" y="323155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66973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74249F6C-42D1-DC36-8A95-19F455FF5D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16459" y="1462315"/>
            <a:ext cx="4061357" cy="3109686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557E60F-00CC-18FF-673B-A5C4672478B8}"/>
              </a:ext>
            </a:extLst>
          </p:cNvPr>
          <p:cNvSpPr txBox="1"/>
          <p:nvPr/>
        </p:nvSpPr>
        <p:spPr>
          <a:xfrm>
            <a:off x="1081349" y="783772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6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B7B2AB7-9C87-5C45-AE04-EE396DBE905C}"/>
              </a:ext>
            </a:extLst>
          </p:cNvPr>
          <p:cNvSpPr txBox="1"/>
          <p:nvPr/>
        </p:nvSpPr>
        <p:spPr>
          <a:xfrm>
            <a:off x="3603508" y="5048125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4E0FA83-982E-D0D9-0760-C32DD1A81D32}"/>
              </a:ext>
            </a:extLst>
          </p:cNvPr>
          <p:cNvSpPr txBox="1"/>
          <p:nvPr/>
        </p:nvSpPr>
        <p:spPr>
          <a:xfrm>
            <a:off x="9097335" y="504812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2C7BD541-9C64-5097-3D82-1A2119FAC2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14186" y="1177236"/>
            <a:ext cx="4787900" cy="33947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876900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84EDB2F-336B-9572-CFA7-FCFE3331E91A}"/>
              </a:ext>
            </a:extLst>
          </p:cNvPr>
          <p:cNvSpPr txBox="1"/>
          <p:nvPr/>
        </p:nvSpPr>
        <p:spPr>
          <a:xfrm>
            <a:off x="863635" y="522515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7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6FF44A7-EAF7-D86F-8FC0-F0B33FFEAAA6}"/>
              </a:ext>
            </a:extLst>
          </p:cNvPr>
          <p:cNvSpPr txBox="1"/>
          <p:nvPr/>
        </p:nvSpPr>
        <p:spPr>
          <a:xfrm>
            <a:off x="3603508" y="5048125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1E6D038-23A0-54B6-B2F8-ED7CF2BF85D5}"/>
              </a:ext>
            </a:extLst>
          </p:cNvPr>
          <p:cNvSpPr txBox="1"/>
          <p:nvPr/>
        </p:nvSpPr>
        <p:spPr>
          <a:xfrm>
            <a:off x="9097335" y="504812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B0575D89-E52A-4648-D31C-8AA9D9E71A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3521" y="1286329"/>
            <a:ext cx="4213155" cy="3253014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B03FFFA-2473-2059-A09D-D5E744359973}"/>
              </a:ext>
            </a:extLst>
          </p:cNvPr>
          <p:cNvSpPr txBox="1"/>
          <p:nvPr/>
        </p:nvSpPr>
        <p:spPr>
          <a:xfrm>
            <a:off x="4722268" y="4239736"/>
            <a:ext cx="1165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mentum</a:t>
            </a:r>
            <a:r>
              <a:rPr lang="en-US" altLang="ja-JP" sz="1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FD59A0B8-9237-200A-5C14-554BF103DB12}"/>
              </a:ext>
            </a:extLst>
          </p:cNvPr>
          <p:cNvCxnSpPr>
            <a:cxnSpLocks/>
          </p:cNvCxnSpPr>
          <p:nvPr/>
        </p:nvCxnSpPr>
        <p:spPr>
          <a:xfrm flipH="1" flipV="1">
            <a:off x="4104234" y="3522525"/>
            <a:ext cx="618034" cy="717211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図 11">
            <a:extLst>
              <a:ext uri="{FF2B5EF4-FFF2-40B4-BE49-F238E27FC236}">
                <a16:creationId xmlns:a16="http://schemas.microsoft.com/office/drawing/2014/main" id="{BEDF122C-DA64-54BD-5174-5A6B5BA77B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15342" y="1231533"/>
            <a:ext cx="4782845" cy="33775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27079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3</TotalTime>
  <Words>85</Words>
  <Application>Microsoft Macintosh PowerPoint</Application>
  <PresentationFormat>ワイド画面</PresentationFormat>
  <Paragraphs>32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3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Microsoft Office User</cp:lastModifiedBy>
  <cp:revision>3</cp:revision>
  <dcterms:created xsi:type="dcterms:W3CDTF">2023-04-04T06:38:57Z</dcterms:created>
  <dcterms:modified xsi:type="dcterms:W3CDTF">2023-04-04T09:22:21Z</dcterms:modified>
</cp:coreProperties>
</file>